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Stile chi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60"/>
  </p:normalViewPr>
  <p:slideViewPr>
    <p:cSldViewPr snapToGrid="0">
      <p:cViewPr varScale="1">
        <p:scale>
          <a:sx n="64" d="100"/>
          <a:sy n="64" d="100"/>
        </p:scale>
        <p:origin x="97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C7A7047-4CAC-C587-0446-DF8A159016F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9E4B5BE4-A41D-FA2C-923B-2BA43B89DC0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77351C1-BB9E-4C9E-626D-0F3E1975A5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AC43F-9588-4D3A-9155-F30FADF5454E}" type="datetimeFigureOut">
              <a:rPr lang="it-IT" smtClean="0"/>
              <a:t>25/03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DB5522B-A813-8183-72CA-3268902756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20608A1-405B-110B-D36F-90F4AF79E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4EF45-50CB-4EE8-BD01-2E16C47AE8D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25328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1610E05-B9D0-81F1-F2FD-6FA2817A03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C55AD317-0B15-71DC-CA51-F3F47732F6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73E0692-DAEA-66CA-7B4A-44FF63A705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AC43F-9588-4D3A-9155-F30FADF5454E}" type="datetimeFigureOut">
              <a:rPr lang="it-IT" smtClean="0"/>
              <a:t>25/03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DC6A2A0-7300-80DF-6F91-FD22552B9A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A61CFC8-B21C-F67D-8B0C-638913EBCA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4EF45-50CB-4EE8-BD01-2E16C47AE8D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89427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9F04E956-923E-B458-BDD3-F9D47637A52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984A8FFF-20B7-9499-D755-B6F6CB7892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7B20F35-8D16-50CD-4DBD-2B5496D3B8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AC43F-9588-4D3A-9155-F30FADF5454E}" type="datetimeFigureOut">
              <a:rPr lang="it-IT" smtClean="0"/>
              <a:t>25/03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0DBD487-41A3-1C9A-E739-5B1295C6E0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573C952-76B1-194C-5B81-B391877375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4EF45-50CB-4EE8-BD01-2E16C47AE8D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500954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BC7BFD4-186A-D158-BA9F-8786615F81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AFF61FB-99D4-21B7-E1AF-61633154FA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1C2C008-B134-1F77-415A-5CDF143A4F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AC43F-9588-4D3A-9155-F30FADF5454E}" type="datetimeFigureOut">
              <a:rPr lang="it-IT" smtClean="0"/>
              <a:t>25/03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26E768F-9107-0F16-84ED-7360516A73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6DD1063-A186-69C6-579F-5C732E1CE7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4EF45-50CB-4EE8-BD01-2E16C47AE8D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05021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E8AAE05-7AA3-9979-4958-788D5F22A8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2A0FE7D-1341-562B-9BEF-12474A06E9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915EAC0-D864-39C0-0CF2-C51CBFF231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AC43F-9588-4D3A-9155-F30FADF5454E}" type="datetimeFigureOut">
              <a:rPr lang="it-IT" smtClean="0"/>
              <a:t>25/03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E2383B5-530B-1895-2507-B568078D42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BCFDD9B-5D87-0881-B928-4B5316DBEA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4EF45-50CB-4EE8-BD01-2E16C47AE8D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95013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7381C1B-6EF9-7F8F-DD4C-733FFF5214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4C6F301-1AC4-0166-8EFF-960F965D724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4E163064-4A65-0081-6B3B-836FF75BDF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28BE526-920C-643B-4163-233721B9EC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AC43F-9588-4D3A-9155-F30FADF5454E}" type="datetimeFigureOut">
              <a:rPr lang="it-IT" smtClean="0"/>
              <a:t>25/03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FD7DDCD-C474-85C9-3E0F-35DA3DCA31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39F7817-27DC-BFB3-A94C-500D5C4886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4EF45-50CB-4EE8-BD01-2E16C47AE8D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33257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DEBC494-3168-4C3A-7184-CA69A0CAF2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1255CAA-5E71-4D5B-E126-CC9426CD0A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52E49563-962F-EF44-56E8-5D297E9DC7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1C2C25B0-744E-F8F2-7693-3068ABD669C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04F56EA5-AE16-C0A8-0ABF-01C9CD69356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7F1C9277-5645-4D42-58BB-D45EB97CC0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AC43F-9588-4D3A-9155-F30FADF5454E}" type="datetimeFigureOut">
              <a:rPr lang="it-IT" smtClean="0"/>
              <a:t>25/03/20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3691F284-AA96-61AD-9FED-1BF4E3AD01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F370D0B6-EFD8-3C18-81F7-C5C7C734AF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4EF45-50CB-4EE8-BD01-2E16C47AE8D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645888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D23E000-6C22-3296-FE2A-D027B34938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EDEAD77A-B848-0092-273A-7A664E0EE5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AC43F-9588-4D3A-9155-F30FADF5454E}" type="datetimeFigureOut">
              <a:rPr lang="it-IT" smtClean="0"/>
              <a:t>25/03/20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F25C20FE-148E-6D6A-03DA-5CB4E21BAE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A85CCA69-BDCE-6FBC-C863-9C1DBEE250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4EF45-50CB-4EE8-BD01-2E16C47AE8D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49727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D53B7652-6541-5333-5184-FAFCDDFF03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AC43F-9588-4D3A-9155-F30FADF5454E}" type="datetimeFigureOut">
              <a:rPr lang="it-IT" smtClean="0"/>
              <a:t>25/03/20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4CA2DDA-B509-CDC1-6510-CF459546AB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41A8DED9-DF41-944F-D7B6-FB523A16BC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4EF45-50CB-4EE8-BD01-2E16C47AE8D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75478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2324C52-CEF4-BE48-BBF5-3ACEBE6786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82E3D71-CAC6-C65F-C8C6-2390B96621A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DDC4728-E184-6CA0-1087-76C8ED00E6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5DDEA86-D3C8-2E52-3969-9D75C68F47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AC43F-9588-4D3A-9155-F30FADF5454E}" type="datetimeFigureOut">
              <a:rPr lang="it-IT" smtClean="0"/>
              <a:t>25/03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FC82627-D06D-53EA-98F1-3F808A510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63984CD-8B17-2A52-5995-B9E26F89E4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4EF45-50CB-4EE8-BD01-2E16C47AE8D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476569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29DA90F-4EF3-5D96-4D74-0F6388AC28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C1720C7A-5CA6-CA4D-FA8F-19750D99B04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8078CEF-0471-F1CE-6988-8D729AFF7F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3B6FEA5-0F08-E029-249C-C6FBCD3F52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AC43F-9588-4D3A-9155-F30FADF5454E}" type="datetimeFigureOut">
              <a:rPr lang="it-IT" smtClean="0"/>
              <a:t>25/03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1DA3571-CED4-EDCA-FEDE-90B7216825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6A7123E-6EA9-3540-2883-01B2246FC6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4EF45-50CB-4EE8-BD01-2E16C47AE8D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907620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96F513E9-579C-AB15-D03B-6A48BCABC8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919616B-3774-412A-B914-CBE81102EF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ECEB737-AC2E-C16F-772F-EEC87BA2CA5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D5AC43F-9588-4D3A-9155-F30FADF5454E}" type="datetimeFigureOut">
              <a:rPr lang="it-IT" smtClean="0"/>
              <a:t>25/03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3DB726F-C46F-3A11-4D5D-AADDA587194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ABCFE61-4B72-38E2-5E5A-11733D5434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004EF45-50CB-4EE8-BD01-2E16C47AE8D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645139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Tabella 8">
            <a:extLst>
              <a:ext uri="{FF2B5EF4-FFF2-40B4-BE49-F238E27FC236}">
                <a16:creationId xmlns:a16="http://schemas.microsoft.com/office/drawing/2014/main" id="{7D252233-A832-3DA4-F558-737382B23E7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19565240"/>
              </p:ext>
            </p:extLst>
          </p:nvPr>
        </p:nvGraphicFramePr>
        <p:xfrm>
          <a:off x="1730530" y="1379233"/>
          <a:ext cx="8730939" cy="237744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2910313">
                  <a:extLst>
                    <a:ext uri="{9D8B030D-6E8A-4147-A177-3AD203B41FA5}">
                      <a16:colId xmlns:a16="http://schemas.microsoft.com/office/drawing/2014/main" val="3184087963"/>
                    </a:ext>
                  </a:extLst>
                </a:gridCol>
                <a:gridCol w="2910313">
                  <a:extLst>
                    <a:ext uri="{9D8B030D-6E8A-4147-A177-3AD203B41FA5}">
                      <a16:colId xmlns:a16="http://schemas.microsoft.com/office/drawing/2014/main" val="3768228270"/>
                    </a:ext>
                  </a:extLst>
                </a:gridCol>
                <a:gridCol w="2910313">
                  <a:extLst>
                    <a:ext uri="{9D8B030D-6E8A-4147-A177-3AD203B41FA5}">
                      <a16:colId xmlns:a16="http://schemas.microsoft.com/office/drawing/2014/main" val="3352526980"/>
                    </a:ext>
                  </a:extLst>
                </a:gridCol>
              </a:tblGrid>
              <a:tr h="509527">
                <a:tc>
                  <a:txBody>
                    <a:bodyPr/>
                    <a:lstStyle/>
                    <a:p>
                      <a:r>
                        <a:rPr lang="it-IT" dirty="0"/>
                        <a:t>Survival </a:t>
                      </a:r>
                      <a:r>
                        <a:rPr lang="it-IT" dirty="0" err="1"/>
                        <a:t>until</a:t>
                      </a:r>
                      <a:r>
                        <a:rPr lang="it-IT" dirty="0"/>
                        <a:t> day 7</a:t>
                      </a:r>
                    </a:p>
                    <a:p>
                      <a:endParaRPr lang="it-IT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68470484"/>
                  </a:ext>
                </a:extLst>
              </a:tr>
              <a:tr h="1354667">
                <a:tc>
                  <a:txBody>
                    <a:bodyPr/>
                    <a:lstStyle/>
                    <a:p>
                      <a:r>
                        <a:rPr lang="en-US" b="0" u="sng"/>
                        <a:t>Optimal shape:</a:t>
                      </a:r>
                      <a:endParaRPr lang="en-US" b="0" u="sng" dirty="0"/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en-US" dirty="0"/>
                        <a:t>Symmetrical shape</a:t>
                      </a: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en-US" dirty="0"/>
                        <a:t>Not attached to the bottom</a:t>
                      </a: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en-US" dirty="0"/>
                        <a:t>Attached to both pillars</a:t>
                      </a:r>
                      <a:endParaRPr lang="it-IT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u="sng" dirty="0"/>
                        <a:t>Sub-optimal shape</a:t>
                      </a:r>
                      <a:r>
                        <a:rPr lang="en-US" dirty="0"/>
                        <a:t>:</a:t>
                      </a: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en-US" dirty="0"/>
                        <a:t>Asymmetrical shape</a:t>
                      </a: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en-US" dirty="0"/>
                        <a:t>Almost detached from one of the pillars</a:t>
                      </a:r>
                    </a:p>
                    <a:p>
                      <a:endParaRPr lang="it-IT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u="sng" dirty="0" err="1"/>
                        <a:t>Unaccetable</a:t>
                      </a:r>
                      <a:r>
                        <a:rPr lang="en-US" dirty="0"/>
                        <a:t>:</a:t>
                      </a: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en-US" dirty="0"/>
                        <a:t>Completely detached from one or both pillars</a:t>
                      </a: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en-US" dirty="0"/>
                        <a:t>Completely attached to bottom well (2D growing)</a:t>
                      </a:r>
                    </a:p>
                    <a:p>
                      <a:endParaRPr lang="it-IT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11069690"/>
                  </a:ext>
                </a:extLst>
              </a:tr>
            </a:tbl>
          </a:graphicData>
        </a:graphic>
      </p:graphicFrame>
      <p:sp>
        <p:nvSpPr>
          <p:cNvPr id="10" name="CasellaDiTesto 9">
            <a:extLst>
              <a:ext uri="{FF2B5EF4-FFF2-40B4-BE49-F238E27FC236}">
                <a16:creationId xmlns:a16="http://schemas.microsoft.com/office/drawing/2014/main" id="{5C7A0FD3-E902-B232-D8C7-37C369FFE322}"/>
              </a:ext>
            </a:extLst>
          </p:cNvPr>
          <p:cNvSpPr txBox="1"/>
          <p:nvPr/>
        </p:nvSpPr>
        <p:spPr>
          <a:xfrm>
            <a:off x="2460884" y="4201631"/>
            <a:ext cx="72702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 err="1">
                <a:latin typeface="Palatino Linotype" panose="02040502050505030304" pitchFamily="18" charset="0"/>
              </a:rPr>
              <a:t>Table</a:t>
            </a:r>
            <a:r>
              <a:rPr lang="it-IT" sz="1600" dirty="0">
                <a:latin typeface="Palatino Linotype" panose="02040502050505030304" pitchFamily="18" charset="0"/>
              </a:rPr>
              <a:t> S1: </a:t>
            </a:r>
            <a:r>
              <a:rPr lang="it-IT" sz="1600" dirty="0" err="1">
                <a:latin typeface="Palatino Linotype" panose="02040502050505030304" pitchFamily="18" charset="0"/>
              </a:rPr>
              <a:t>morphological</a:t>
            </a:r>
            <a:r>
              <a:rPr lang="it-IT" sz="1600" dirty="0">
                <a:latin typeface="Palatino Linotype" panose="02040502050505030304" pitchFamily="18" charset="0"/>
              </a:rPr>
              <a:t> </a:t>
            </a:r>
            <a:r>
              <a:rPr lang="en-GB" sz="16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Aptos" panose="020B0004020202020204" pitchFamily="34" charset="0"/>
              </a:rPr>
              <a:t>parameters used as acceptance criteria for analysis.</a:t>
            </a:r>
            <a:endParaRPr lang="it-IT" sz="16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104548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60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affaella quarta</dc:creator>
  <cp:lastModifiedBy>raffaella quarta</cp:lastModifiedBy>
  <cp:revision>3</cp:revision>
  <dcterms:created xsi:type="dcterms:W3CDTF">2025-03-12T16:07:39Z</dcterms:created>
  <dcterms:modified xsi:type="dcterms:W3CDTF">2025-03-25T14:39:55Z</dcterms:modified>
</cp:coreProperties>
</file>